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106" d="100"/>
          <a:sy n="106" d="100"/>
        </p:scale>
        <p:origin x="858" y="-3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6019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996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6654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3326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0616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15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4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42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5095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9106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1155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215B4-6E7F-4C5A-9DE7-36F2E676AF73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203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 flipH="1">
            <a:off x="601944" y="7534383"/>
            <a:ext cx="5654111" cy="586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 : Correlation matrix between different traits. </a:t>
            </a:r>
            <a:r>
              <a:rPr lang="en-US" sz="10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ed </a:t>
            </a:r>
            <a:r>
              <a:rPr lang="en-US" sz="100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rcles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cate statistically significant correlations. The color scale indicates the level of significance. The darker the color, the more significant the p value.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21F4651A-D130-4A46-A3E6-9C73689B3E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787"/>
          <a:stretch/>
        </p:blipFill>
        <p:spPr>
          <a:xfrm>
            <a:off x="278144" y="1476867"/>
            <a:ext cx="6301712" cy="5284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0741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7</TotalTime>
  <Words>38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 Dellagi</dc:creator>
  <cp:lastModifiedBy>Alia Dellagi</cp:lastModifiedBy>
  <cp:revision>24</cp:revision>
  <cp:lastPrinted>2021-09-15T09:10:34Z</cp:lastPrinted>
  <dcterms:created xsi:type="dcterms:W3CDTF">2021-04-15T18:38:08Z</dcterms:created>
  <dcterms:modified xsi:type="dcterms:W3CDTF">2021-11-01T16:33:41Z</dcterms:modified>
</cp:coreProperties>
</file>